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8027B-0B8D-4F44-9A5B-579830E73E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E7681-8AA1-4768-8C1A-9F807E5063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66C1A-5061-4E5C-917B-93EF273F17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62A655-3BEA-4D1F-83BE-0F62B9B990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DF20B-BE65-476A-8122-E36A0834DB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D7274-46ED-426B-A9DA-1FDA0DE149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4DADB-C47B-4532-9890-1CCF33EDB4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6B204-C21D-4867-BD28-EF2A0721D8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0C7A7-AFD6-4563-9E2C-7FAD88C138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52946-5054-4E60-900E-6CD65FF9A6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DF090-0642-4C6A-939A-9660FA894E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2BB2F-56AD-4FDB-9F92-67EF3F10EF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E816AB-78B9-4D09-934D-F6B9E64ED27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52720" y="6332400"/>
            <a:ext cx="266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Days post agro infe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rot="16200000">
            <a:off x="1611000" y="4469040"/>
            <a:ext cx="2808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Relative mRNA leve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348000" y="3308400"/>
            <a:ext cx="936720" cy="142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3276720" y="3255840"/>
            <a:ext cx="3311280" cy="309888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4211640" y="518004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564000" y="3666960"/>
            <a:ext cx="574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012000" y="489276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435640" y="553392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788000" y="5396040"/>
            <a:ext cx="57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119"/>
          <p:cNvGrpSpPr/>
          <p:nvPr/>
        </p:nvGrpSpPr>
        <p:grpSpPr>
          <a:xfrm>
            <a:off x="1765800" y="880920"/>
            <a:ext cx="6017760" cy="1933560"/>
            <a:chOff x="1765800" y="880920"/>
            <a:chExt cx="6017760" cy="1933560"/>
          </a:xfrm>
        </p:grpSpPr>
        <p:pic>
          <p:nvPicPr>
            <p:cNvPr id="51" name="Picture 2" descr=""/>
            <p:cNvPicPr/>
            <p:nvPr/>
          </p:nvPicPr>
          <p:blipFill>
            <a:blip r:embed="rId2"/>
            <a:stretch/>
          </p:blipFill>
          <p:spPr>
            <a:xfrm>
              <a:off x="2338200" y="893880"/>
              <a:ext cx="5445360" cy="1065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Line 3"/>
            <p:cNvSpPr/>
            <p:nvPr/>
          </p:nvSpPr>
          <p:spPr>
            <a:xfrm>
              <a:off x="2604960" y="1515960"/>
              <a:ext cx="266760" cy="482760"/>
            </a:xfrm>
            <a:prstGeom prst="line">
              <a:avLst/>
            </a:prstGeom>
            <a:ln w="28440">
              <a:solidFill>
                <a:srgbClr val="f10b0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4"/>
            <p:cNvSpPr/>
            <p:nvPr/>
          </p:nvSpPr>
          <p:spPr>
            <a:xfrm>
              <a:off x="5132520" y="880920"/>
              <a:ext cx="0" cy="749520"/>
            </a:xfrm>
            <a:prstGeom prst="line">
              <a:avLst/>
            </a:prstGeom>
            <a:ln w="28440">
              <a:solidFill>
                <a:srgbClr val="f10b0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5"/>
            <p:cNvSpPr/>
            <p:nvPr/>
          </p:nvSpPr>
          <p:spPr>
            <a:xfrm>
              <a:off x="5818320" y="880920"/>
              <a:ext cx="0" cy="749520"/>
            </a:xfrm>
            <a:prstGeom prst="line">
              <a:avLst/>
            </a:prstGeom>
            <a:ln w="28440">
              <a:solidFill>
                <a:srgbClr val="f10b0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6"/>
            <p:cNvSpPr/>
            <p:nvPr/>
          </p:nvSpPr>
          <p:spPr>
            <a:xfrm>
              <a:off x="5119560" y="2068560"/>
              <a:ext cx="698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7"/>
            <p:cNvSpPr/>
            <p:nvPr/>
          </p:nvSpPr>
          <p:spPr>
            <a:xfrm>
              <a:off x="2859120" y="2068560"/>
              <a:ext cx="228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8"/>
            <p:cNvSpPr/>
            <p:nvPr/>
          </p:nvSpPr>
          <p:spPr>
            <a:xfrm>
              <a:off x="3057120" y="2200320"/>
              <a:ext cx="1997280" cy="61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groinfected part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f the leaf ( </a:t>
              </a:r>
              <a:r>
                <a:rPr b="1" lang="fr-FR" sz="1600" spc="-1" strike="noStrike" baseline="-25000">
                  <a:solidFill>
                    <a:srgbClr val="000000"/>
                  </a:solidFill>
                  <a:latin typeface="Arial"/>
                  <a:ea typeface="ＭＳ Ｐゴシック"/>
                </a:rPr>
                <a:t>˜</a:t>
              </a: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 cm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9"/>
            <p:cNvSpPr/>
            <p:nvPr/>
          </p:nvSpPr>
          <p:spPr>
            <a:xfrm>
              <a:off x="1765800" y="2200320"/>
              <a:ext cx="1160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iscarde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0"/>
            <p:cNvSpPr/>
            <p:nvPr/>
          </p:nvSpPr>
          <p:spPr>
            <a:xfrm>
              <a:off x="5000400" y="2200320"/>
              <a:ext cx="1884600" cy="61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djacent part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f the leaf ( </a:t>
              </a:r>
              <a:r>
                <a:rPr b="1" lang="fr-FR" sz="1600" spc="-1" strike="noStrike" baseline="-25000">
                  <a:solidFill>
                    <a:srgbClr val="000000"/>
                  </a:solidFill>
                  <a:latin typeface="Arial"/>
                  <a:ea typeface="ＭＳ Ｐゴシック"/>
                </a:rPr>
                <a:t>˜</a:t>
              </a: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 cm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468360" y="260280"/>
            <a:ext cx="71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11280" y="3068640"/>
            <a:ext cx="71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9T06:36:03Z</dcterms:created>
  <dc:creator>GUIDERDONI</dc:creator>
  <dc:description/>
  <dc:language>en-US</dc:language>
  <cp:lastModifiedBy>GUIDERDONI</cp:lastModifiedBy>
  <dcterms:modified xsi:type="dcterms:W3CDTF">2012-06-09T15:33:07Z</dcterms:modified>
  <cp:revision>2</cp:revision>
  <dc:subject/>
  <dc:title>Diapositive 1</dc:title>
</cp:coreProperties>
</file>